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5" r:id="rId2"/>
    <p:sldId id="296" r:id="rId3"/>
    <p:sldId id="276" r:id="rId4"/>
    <p:sldId id="298" r:id="rId5"/>
    <p:sldId id="299" r:id="rId6"/>
    <p:sldId id="297" r:id="rId7"/>
    <p:sldId id="317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7988"/>
    <p:restoredTop sz="94629"/>
  </p:normalViewPr>
  <p:slideViewPr>
    <p:cSldViewPr snapToGrid="0" snapToObjects="1">
      <p:cViewPr varScale="1">
        <p:scale>
          <a:sx n="118" d="100"/>
          <a:sy n="118" d="100"/>
        </p:scale>
        <p:origin x="216" y="13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10CC9B-7B1E-CF4C-A1FC-5F0280AA1B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5BD323A-BC9A-C247-A85B-AE7209660BA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D4263B-D862-0945-B607-3B0A6D8E0F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C33409-A37A-084C-A43F-ABF9511A5A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FFDE88-DF47-344D-8231-9BC913A1F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8630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30CD77-F504-F342-B644-183F24167F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7F1829-14D9-0B47-AB90-5072EE1EEF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94CF12-3553-2E47-A20D-198EA7042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33959C-54C1-4345-9E31-9B077727A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B79B4D-7AD0-9945-B7E7-56751B8FD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6014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4B07CE7-78C6-244D-9ED0-491941318E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9729ED-238E-AF45-ABC0-B740B2C171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704D94-4165-6846-9A82-91539F8CDF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F381D2-EEC0-414B-A115-AF0DF95B7E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556490-8E6B-144A-BBC1-B7C94F1CB4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1270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4EE291-F8EE-3942-874C-F0658844CA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6F457D-75E4-7749-9C5C-F45CF8CE7F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8B97AE-749D-9645-8094-6C9C90896A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1BF087-78B9-B242-A803-1A3D5E147C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0944F8-9E98-7947-848E-1279A31A9A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14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A5BEE-419F-5149-B366-775BC7A248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00BBE8-DCF8-C14A-A570-B3B1A3BB0C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C794666-DFF6-2F42-90C1-C59ED106C0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749A5C-2F2E-8645-992F-021AD9ACF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A2670F-DAE0-F74B-A6F4-42DB0A8456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538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99C694-99B2-E647-9579-8AE5999504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2A3771-971D-0440-BB29-A50821438F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06A70B2-77E4-6E40-9E6F-B3507E2305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FD6588-89CD-EB46-9569-9EC8A5B2F0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6EA13F-B45E-CE4E-8FC6-646F8ABCA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F4BCE09-0424-444E-8D07-6ECF1377A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4192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FA7777-D6C2-A243-86FC-44F5BD25F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61ED36-8841-9B41-A364-CD146F2183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30244C9-136E-6E4A-873C-17DED49496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60127BA-17EB-FE4B-9666-9B3E42CF23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2D0FB0C-C046-3648-8C7B-8F9FD85F253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C291C65-54C2-B14B-B61D-FBEF86F2EC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193C9F6-578F-B644-AB75-A03F97732B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474A2A7-1136-2D40-AB51-0FD248EAF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291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550FA5-814D-5448-A439-DF86269532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7084CC-A32E-B448-91D8-EE2FA6789A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3819BCD-8FE5-934C-A752-99DD30BF4D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3DC038A-2407-ED47-BD6B-D39E6D2A63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85084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CC87A81-50C0-C948-BBA8-E5C679500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81D1FB1-D794-7045-B169-E1FFBF05E8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F2C295-E2C1-EA42-8417-FDAAE76AB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0806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CDC0E9-C28E-2146-BF24-BBDD0B7522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ED9093-E362-7E41-9C9E-482FD756EB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4F269D0-F6C3-6641-8772-B09D4203F1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1EFE82-A190-7A40-8EB8-5B0939E84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4DFF52-9C0E-2948-877B-EFF73D0A5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E82FBB-D105-9248-AE5A-9439BC9257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5192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12BCBE-144A-1B44-B4CE-72717B2C9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21C5C9A-23B5-D94D-BFFD-85A445960FC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5FC3456-1C68-654D-89E4-AD61AF310E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9421431-B574-8542-8517-0EF898D1A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0CDA23B-0175-A34F-AAE6-5E0C6A8DF1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4772A1-B7E7-C942-A62F-85BA600417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337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F2D84A4-4A91-E340-BB3F-D5E5CECE03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E10A34-89B0-DF47-8C2A-B70B9D1563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95EB6B-DD35-DB40-B1D4-60052BAD2D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EAC6C-0108-3C4C-81E8-80C10AB96372}" type="datetimeFigureOut">
              <a:rPr lang="en-US" smtClean="0"/>
              <a:t>2/15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ADA950-A5F3-A04B-BE12-57F26A316FE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CF8D8D-FD0E-E140-8BBB-CC86194C909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B155FE-7ECD-4549-9EF4-EAD20FA160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9855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2799F12-24F4-5F40-8C1D-FDE8ED887B4A}"/>
              </a:ext>
            </a:extLst>
          </p:cNvPr>
          <p:cNvGrpSpPr/>
          <p:nvPr/>
        </p:nvGrpSpPr>
        <p:grpSpPr>
          <a:xfrm>
            <a:off x="4044327" y="32657"/>
            <a:ext cx="5704115" cy="1194266"/>
            <a:chOff x="2052241" y="57877"/>
            <a:chExt cx="5704115" cy="1194266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B27CC100-882B-9D4E-B628-405CD8884E9D}"/>
                </a:ext>
              </a:extLst>
            </p:cNvPr>
            <p:cNvGrpSpPr/>
            <p:nvPr/>
          </p:nvGrpSpPr>
          <p:grpSpPr>
            <a:xfrm>
              <a:off x="2052241" y="57877"/>
              <a:ext cx="5704115" cy="1194266"/>
              <a:chOff x="1714500" y="278007"/>
              <a:chExt cx="5704115" cy="1194266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77331552-2025-C34E-A0F8-82D7F7CE389F}"/>
                  </a:ext>
                </a:extLst>
              </p:cNvPr>
              <p:cNvSpPr txBox="1"/>
              <p:nvPr/>
            </p:nvSpPr>
            <p:spPr>
              <a:xfrm>
                <a:off x="2209800" y="1102941"/>
                <a:ext cx="520881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S      TS.         CS      TS.  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4A8D1A0D-76E7-F04E-966B-8A07BDBA1B64}"/>
                  </a:ext>
                </a:extLst>
              </p:cNvPr>
              <p:cNvSpPr txBox="1"/>
              <p:nvPr/>
            </p:nvSpPr>
            <p:spPr>
              <a:xfrm>
                <a:off x="1714500" y="278007"/>
                <a:ext cx="17634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miR12475</a:t>
                </a:r>
              </a:p>
            </p:txBody>
          </p:sp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6AE2DE1-5985-8A47-8D81-6E9D570A0F0F}"/>
                </a:ext>
              </a:extLst>
            </p:cNvPr>
            <p:cNvSpPr txBox="1"/>
            <p:nvPr/>
          </p:nvSpPr>
          <p:spPr>
            <a:xfrm>
              <a:off x="2280839" y="470344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/>
                <a:t>O. </a:t>
              </a:r>
              <a:r>
                <a:rPr lang="en-US" i="1" dirty="0" err="1"/>
                <a:t>coarctata</a:t>
              </a:r>
              <a:r>
                <a:rPr lang="en-US" i="1" dirty="0"/>
                <a:t>        S. </a:t>
              </a:r>
              <a:r>
                <a:rPr lang="en-US" i="1" dirty="0" err="1"/>
                <a:t>maritima</a:t>
              </a:r>
              <a:endParaRPr lang="en-US" i="1" dirty="0"/>
            </a:p>
          </p:txBody>
        </p:sp>
      </p:grpSp>
      <p:pic>
        <p:nvPicPr>
          <p:cNvPr id="9" name="Picture 8">
            <a:extLst>
              <a:ext uri="{FF2B5EF4-FFF2-40B4-BE49-F238E27FC236}">
                <a16:creationId xmlns:a16="http://schemas.microsoft.com/office/drawing/2014/main" id="{061DD461-9607-A744-9594-5E313C77076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9910" y="1220470"/>
            <a:ext cx="2832100" cy="5422900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C1D38909-429F-8E48-B1BA-02A3745A650B}"/>
              </a:ext>
            </a:extLst>
          </p:cNvPr>
          <p:cNvSpPr/>
          <p:nvPr/>
        </p:nvSpPr>
        <p:spPr>
          <a:xfrm>
            <a:off x="484595" y="1303552"/>
            <a:ext cx="2888932" cy="43088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IN" sz="1100" b="1" dirty="0">
                <a:latin typeface="Calibri" panose="020F0502020204030204" pitchFamily="34" charset="0"/>
              </a:rPr>
              <a:t>S6 File: Uncropped Northern blot images of </a:t>
            </a:r>
          </a:p>
          <a:p>
            <a:r>
              <a:rPr lang="en-IN" sz="1100" b="1" dirty="0">
                <a:latin typeface="Calibri" panose="020F0502020204030204" pitchFamily="34" charset="0"/>
              </a:rPr>
              <a:t>novel miRNAs  in </a:t>
            </a:r>
            <a:r>
              <a:rPr lang="en-IN" sz="1100" b="1" i="1" dirty="0">
                <a:latin typeface="Calibri" panose="020F0502020204030204" pitchFamily="34" charset="0"/>
              </a:rPr>
              <a:t>S. </a:t>
            </a:r>
            <a:r>
              <a:rPr lang="en-IN" sz="1100" b="1" i="1" dirty="0" err="1">
                <a:latin typeface="Calibri" panose="020F0502020204030204" pitchFamily="34" charset="0"/>
              </a:rPr>
              <a:t>maritima</a:t>
            </a:r>
            <a:r>
              <a:rPr lang="en-IN" sz="1100" b="1" i="1" dirty="0">
                <a:latin typeface="Calibri" panose="020F0502020204030204" pitchFamily="34" charset="0"/>
              </a:rPr>
              <a:t> </a:t>
            </a:r>
            <a:r>
              <a:rPr lang="en-IN" sz="1100" b="1" dirty="0">
                <a:latin typeface="Calibri" panose="020F0502020204030204" pitchFamily="34" charset="0"/>
              </a:rPr>
              <a:t>and </a:t>
            </a:r>
            <a:r>
              <a:rPr lang="en-IN" sz="1100" b="1" i="1" dirty="0">
                <a:latin typeface="Calibri" panose="020F0502020204030204" pitchFamily="34" charset="0"/>
              </a:rPr>
              <a:t>O. </a:t>
            </a:r>
            <a:r>
              <a:rPr lang="en-IN" sz="1100" b="1" i="1" dirty="0" err="1">
                <a:latin typeface="Calibri" panose="020F0502020204030204" pitchFamily="34" charset="0"/>
              </a:rPr>
              <a:t>coarctata</a:t>
            </a:r>
            <a:endParaRPr lang="en-IN" sz="1100" i="1" dirty="0">
              <a:latin typeface="Calibri" panose="020F050202020403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4F0C6AC3-AC91-6441-B3E0-B2F4F5A4F0EA}"/>
              </a:ext>
            </a:extLst>
          </p:cNvPr>
          <p:cNvSpPr/>
          <p:nvPr/>
        </p:nvSpPr>
        <p:spPr>
          <a:xfrm>
            <a:off x="484595" y="328515"/>
            <a:ext cx="2922634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IN" sz="1100" b="1" dirty="0">
                <a:latin typeface="Arial" panose="020B0604020202020204" pitchFamily="34" charset="0"/>
              </a:rPr>
              <a:t>Identification and expression analysis of miRNAs and elucidation of their role in salt tolerance in rice varieties susceptible and tolerant to salinity</a:t>
            </a:r>
            <a:endParaRPr lang="en-IN" sz="11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06893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CBE7E1E5-FF51-0640-90C7-849AD6964046}"/>
              </a:ext>
            </a:extLst>
          </p:cNvPr>
          <p:cNvGrpSpPr/>
          <p:nvPr/>
        </p:nvGrpSpPr>
        <p:grpSpPr>
          <a:xfrm>
            <a:off x="2836012" y="0"/>
            <a:ext cx="5704115" cy="1194266"/>
            <a:chOff x="2052241" y="57877"/>
            <a:chExt cx="5704115" cy="119426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C66C0B98-C2C2-3D47-8FA2-A752F1E27194}"/>
                </a:ext>
              </a:extLst>
            </p:cNvPr>
            <p:cNvGrpSpPr/>
            <p:nvPr/>
          </p:nvGrpSpPr>
          <p:grpSpPr>
            <a:xfrm>
              <a:off x="2052241" y="57877"/>
              <a:ext cx="5704115" cy="1194266"/>
              <a:chOff x="1714500" y="278007"/>
              <a:chExt cx="5704115" cy="1194266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A983828C-599A-4E49-AA0D-1CC5B983E75B}"/>
                  </a:ext>
                </a:extLst>
              </p:cNvPr>
              <p:cNvSpPr txBox="1"/>
              <p:nvPr/>
            </p:nvSpPr>
            <p:spPr>
              <a:xfrm>
                <a:off x="2209800" y="1102941"/>
                <a:ext cx="520881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S      TS.                                       CS            TS.  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9AE786D-C021-4E4C-A7FF-911119F97065}"/>
                  </a:ext>
                </a:extLst>
              </p:cNvPr>
              <p:cNvSpPr txBox="1"/>
              <p:nvPr/>
            </p:nvSpPr>
            <p:spPr>
              <a:xfrm>
                <a:off x="1714500" y="278007"/>
                <a:ext cx="17634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miR12478</a:t>
                </a:r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742DB29-C390-4049-879E-725AC16A7953}"/>
                </a:ext>
              </a:extLst>
            </p:cNvPr>
            <p:cNvSpPr txBox="1"/>
            <p:nvPr/>
          </p:nvSpPr>
          <p:spPr>
            <a:xfrm>
              <a:off x="2280839" y="470344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/>
                <a:t>O. </a:t>
              </a:r>
              <a:r>
                <a:rPr lang="en-US" i="1" dirty="0" err="1"/>
                <a:t>Coarctata</a:t>
              </a:r>
              <a:r>
                <a:rPr lang="en-US" i="1" dirty="0"/>
                <a:t>        		       S. </a:t>
              </a:r>
              <a:r>
                <a:rPr lang="en-US" i="1" dirty="0" err="1"/>
                <a:t>maritima</a:t>
              </a:r>
              <a:endParaRPr lang="en-US" i="1" dirty="0"/>
            </a:p>
          </p:txBody>
        </p:sp>
      </p:grpSp>
      <p:pic>
        <p:nvPicPr>
          <p:cNvPr id="11" name="Picture 10">
            <a:extLst>
              <a:ext uri="{FF2B5EF4-FFF2-40B4-BE49-F238E27FC236}">
                <a16:creationId xmlns:a16="http://schemas.microsoft.com/office/drawing/2014/main" id="{4B9E4503-8C66-9F4A-BD93-5DF9EA4F52E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40812" y="1237400"/>
            <a:ext cx="4494428" cy="52312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545490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E14A5869-83BB-6045-8F21-105A4C5856A0}"/>
              </a:ext>
            </a:extLst>
          </p:cNvPr>
          <p:cNvGrpSpPr/>
          <p:nvPr/>
        </p:nvGrpSpPr>
        <p:grpSpPr>
          <a:xfrm>
            <a:off x="4163785" y="108803"/>
            <a:ext cx="5704115" cy="1194266"/>
            <a:chOff x="1714500" y="278007"/>
            <a:chExt cx="5704115" cy="1194266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2BF1889A-55D1-1046-A9C2-D51B026E217D}"/>
                </a:ext>
              </a:extLst>
            </p:cNvPr>
            <p:cNvSpPr txBox="1"/>
            <p:nvPr/>
          </p:nvSpPr>
          <p:spPr>
            <a:xfrm>
              <a:off x="2209800" y="1102941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 CS      TS. 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4DFFD87-D0CF-7847-9ED0-C80938922257}"/>
                </a:ext>
              </a:extLst>
            </p:cNvPr>
            <p:cNvSpPr txBox="1"/>
            <p:nvPr/>
          </p:nvSpPr>
          <p:spPr>
            <a:xfrm>
              <a:off x="1714500" y="278007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77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13605B30-54CC-D540-B888-4C20B9EA35BC}"/>
              </a:ext>
            </a:extLst>
          </p:cNvPr>
          <p:cNvSpPr txBox="1"/>
          <p:nvPr/>
        </p:nvSpPr>
        <p:spPr>
          <a:xfrm>
            <a:off x="4163785" y="536354"/>
            <a:ext cx="5208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O. </a:t>
            </a:r>
            <a:r>
              <a:rPr lang="en-US" i="1" dirty="0" err="1"/>
              <a:t>Coarctata</a:t>
            </a:r>
            <a:r>
              <a:rPr lang="en-US" i="1" dirty="0"/>
              <a:t>        S. </a:t>
            </a:r>
            <a:r>
              <a:rPr lang="en-US" i="1" dirty="0" err="1"/>
              <a:t>maritima</a:t>
            </a:r>
            <a:endParaRPr lang="en-US" i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9C1BC27-9582-F743-B73C-C958219F77E4}"/>
              </a:ext>
            </a:extLst>
          </p:cNvPr>
          <p:cNvSpPr txBox="1"/>
          <p:nvPr/>
        </p:nvSpPr>
        <p:spPr>
          <a:xfrm>
            <a:off x="9078685" y="3429000"/>
            <a:ext cx="22533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ifferent pic from the one in manuscript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77D070C-C3D7-8C48-82E5-9F0D03DDEE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63785" y="1447115"/>
            <a:ext cx="3124200" cy="461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20788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DA94A21-CA22-484E-AD64-F85CECB6B157}"/>
              </a:ext>
            </a:extLst>
          </p:cNvPr>
          <p:cNvGrpSpPr/>
          <p:nvPr/>
        </p:nvGrpSpPr>
        <p:grpSpPr>
          <a:xfrm>
            <a:off x="4163785" y="108803"/>
            <a:ext cx="5704115" cy="1194266"/>
            <a:chOff x="1714500" y="278007"/>
            <a:chExt cx="5704115" cy="1194266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A3301D5-5610-564B-8C08-00EB6B123412}"/>
                </a:ext>
              </a:extLst>
            </p:cNvPr>
            <p:cNvSpPr txBox="1"/>
            <p:nvPr/>
          </p:nvSpPr>
          <p:spPr>
            <a:xfrm>
              <a:off x="2209800" y="1102941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    CS      TS.  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145EB854-F287-E44B-A79A-953F00761589}"/>
                </a:ext>
              </a:extLst>
            </p:cNvPr>
            <p:cNvSpPr txBox="1"/>
            <p:nvPr/>
          </p:nvSpPr>
          <p:spPr>
            <a:xfrm>
              <a:off x="1714500" y="278007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79</a:t>
              </a:r>
            </a:p>
          </p:txBody>
        </p: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DAE8F371-10CB-A740-9C50-C9B49BE8E16B}"/>
              </a:ext>
            </a:extLst>
          </p:cNvPr>
          <p:cNvSpPr txBox="1"/>
          <p:nvPr/>
        </p:nvSpPr>
        <p:spPr>
          <a:xfrm>
            <a:off x="4163785" y="536354"/>
            <a:ext cx="5208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O. </a:t>
            </a:r>
            <a:r>
              <a:rPr lang="en-US" i="1" dirty="0" err="1"/>
              <a:t>Coarctata</a:t>
            </a:r>
            <a:r>
              <a:rPr lang="en-US" i="1" dirty="0"/>
              <a:t>        S. </a:t>
            </a:r>
            <a:r>
              <a:rPr lang="en-US" i="1" dirty="0" err="1"/>
              <a:t>maritima</a:t>
            </a:r>
            <a:endParaRPr lang="en-US" i="1" dirty="0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55BDA81B-1D4D-974D-86AA-5CB126CA4F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35021" y="1342103"/>
            <a:ext cx="2984500" cy="467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38596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C13FB797-BD68-3646-A6D9-27FD3B0E4C3F}"/>
              </a:ext>
            </a:extLst>
          </p:cNvPr>
          <p:cNvGrpSpPr/>
          <p:nvPr/>
        </p:nvGrpSpPr>
        <p:grpSpPr>
          <a:xfrm>
            <a:off x="4163785" y="108803"/>
            <a:ext cx="5704115" cy="1194266"/>
            <a:chOff x="1714500" y="278007"/>
            <a:chExt cx="5704115" cy="1194266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93EF3A32-C682-1A4D-BFF3-65E2C045D164}"/>
                </a:ext>
              </a:extLst>
            </p:cNvPr>
            <p:cNvSpPr txBox="1"/>
            <p:nvPr/>
          </p:nvSpPr>
          <p:spPr>
            <a:xfrm>
              <a:off x="2209800" y="1102941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 CS      TS.  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697CC0DE-2D73-D04C-ACA5-C00A3E8FB08E}"/>
                </a:ext>
              </a:extLst>
            </p:cNvPr>
            <p:cNvSpPr txBox="1"/>
            <p:nvPr/>
          </p:nvSpPr>
          <p:spPr>
            <a:xfrm>
              <a:off x="1714500" y="278007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80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DC9B9A5D-F0C6-CF44-BC70-E08888708F71}"/>
              </a:ext>
            </a:extLst>
          </p:cNvPr>
          <p:cNvSpPr txBox="1"/>
          <p:nvPr/>
        </p:nvSpPr>
        <p:spPr>
          <a:xfrm>
            <a:off x="4180718" y="536354"/>
            <a:ext cx="5208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O. </a:t>
            </a:r>
            <a:r>
              <a:rPr lang="en-US" i="1" dirty="0" err="1"/>
              <a:t>Coarctata</a:t>
            </a:r>
            <a:r>
              <a:rPr lang="en-US" i="1" dirty="0"/>
              <a:t>        S. </a:t>
            </a:r>
            <a:r>
              <a:rPr lang="en-US" i="1" dirty="0" err="1"/>
              <a:t>maritima</a:t>
            </a:r>
            <a:endParaRPr lang="en-US" i="1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806DC58-EFEF-E441-9553-64B8E0598F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24804" y="1331120"/>
            <a:ext cx="2541755" cy="40479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98477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B9D5A425-6E4A-704F-B623-7494A198CE6E}"/>
              </a:ext>
            </a:extLst>
          </p:cNvPr>
          <p:cNvGrpSpPr/>
          <p:nvPr/>
        </p:nvGrpSpPr>
        <p:grpSpPr>
          <a:xfrm>
            <a:off x="4044327" y="-81643"/>
            <a:ext cx="5704115" cy="1194266"/>
            <a:chOff x="2052241" y="57877"/>
            <a:chExt cx="5704115" cy="1194266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FE7B6A70-4D69-F645-8E0F-E1980D8A510C}"/>
                </a:ext>
              </a:extLst>
            </p:cNvPr>
            <p:cNvGrpSpPr/>
            <p:nvPr/>
          </p:nvGrpSpPr>
          <p:grpSpPr>
            <a:xfrm>
              <a:off x="2052241" y="57877"/>
              <a:ext cx="5704115" cy="1194266"/>
              <a:chOff x="1714500" y="278007"/>
              <a:chExt cx="5704115" cy="1194266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98AE0780-B3A2-6443-A8CA-D076CCF23BCA}"/>
                  </a:ext>
                </a:extLst>
              </p:cNvPr>
              <p:cNvSpPr txBox="1"/>
              <p:nvPr/>
            </p:nvSpPr>
            <p:spPr>
              <a:xfrm>
                <a:off x="2209800" y="1102941"/>
                <a:ext cx="5208815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CS      TS.         CS      TS.  </a:t>
                </a: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568147A1-DE7E-B343-BEC8-202CCC2132F6}"/>
                  </a:ext>
                </a:extLst>
              </p:cNvPr>
              <p:cNvSpPr txBox="1"/>
              <p:nvPr/>
            </p:nvSpPr>
            <p:spPr>
              <a:xfrm>
                <a:off x="1714500" y="278007"/>
                <a:ext cx="1763486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dirty="0"/>
                  <a:t>miR12481</a:t>
                </a:r>
              </a:p>
            </p:txBody>
          </p:sp>
        </p:grp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568326C6-CF5D-E54A-B24A-19D6932B0C8C}"/>
                </a:ext>
              </a:extLst>
            </p:cNvPr>
            <p:cNvSpPr txBox="1"/>
            <p:nvPr/>
          </p:nvSpPr>
          <p:spPr>
            <a:xfrm>
              <a:off x="2280839" y="470344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i="1" dirty="0"/>
                <a:t>O. </a:t>
              </a:r>
              <a:r>
                <a:rPr lang="en-US" i="1" dirty="0" err="1"/>
                <a:t>Coarctata</a:t>
              </a:r>
              <a:r>
                <a:rPr lang="en-US" i="1" dirty="0"/>
                <a:t>        S. </a:t>
              </a:r>
              <a:r>
                <a:rPr lang="en-US" i="1" dirty="0" err="1"/>
                <a:t>maritima</a:t>
              </a:r>
              <a:endParaRPr lang="en-US" i="1" dirty="0"/>
            </a:p>
          </p:txBody>
        </p:sp>
      </p:grpSp>
      <p:pic>
        <p:nvPicPr>
          <p:cNvPr id="8" name="Picture 7">
            <a:extLst>
              <a:ext uri="{FF2B5EF4-FFF2-40B4-BE49-F238E27FC236}">
                <a16:creationId xmlns:a16="http://schemas.microsoft.com/office/drawing/2014/main" id="{88B3EB3C-BF2C-8F4A-A0B6-2D85C77951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4790" y="1046480"/>
            <a:ext cx="3390900" cy="513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666945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>
            <a:extLst>
              <a:ext uri="{FF2B5EF4-FFF2-40B4-BE49-F238E27FC236}">
                <a16:creationId xmlns:a16="http://schemas.microsoft.com/office/drawing/2014/main" id="{1A0A1A47-8BE5-FD46-B3CF-D562C6D74371}"/>
              </a:ext>
            </a:extLst>
          </p:cNvPr>
          <p:cNvGrpSpPr/>
          <p:nvPr/>
        </p:nvGrpSpPr>
        <p:grpSpPr>
          <a:xfrm>
            <a:off x="4163785" y="108803"/>
            <a:ext cx="5704115" cy="1194266"/>
            <a:chOff x="1714500" y="278007"/>
            <a:chExt cx="5704115" cy="1194266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64384433-E6F8-994E-8E40-BDCE5B07A76C}"/>
                </a:ext>
              </a:extLst>
            </p:cNvPr>
            <p:cNvSpPr txBox="1"/>
            <p:nvPr/>
          </p:nvSpPr>
          <p:spPr>
            <a:xfrm>
              <a:off x="2209800" y="1102941"/>
              <a:ext cx="52088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S      TS.      CS      TS. 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B66D6E73-8CE5-AB4A-83A3-E8C7638C255D}"/>
                </a:ext>
              </a:extLst>
            </p:cNvPr>
            <p:cNvSpPr txBox="1"/>
            <p:nvPr/>
          </p:nvSpPr>
          <p:spPr>
            <a:xfrm>
              <a:off x="1714500" y="278007"/>
              <a:ext cx="17634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miR12482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A5A7B269-1E8D-4E4C-B09E-D434AFBC8B51}"/>
              </a:ext>
            </a:extLst>
          </p:cNvPr>
          <p:cNvSpPr txBox="1"/>
          <p:nvPr/>
        </p:nvSpPr>
        <p:spPr>
          <a:xfrm>
            <a:off x="4163785" y="536354"/>
            <a:ext cx="52088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/>
              <a:t>O. </a:t>
            </a:r>
            <a:r>
              <a:rPr lang="en-US" i="1" dirty="0" err="1"/>
              <a:t>Coarctata</a:t>
            </a:r>
            <a:r>
              <a:rPr lang="en-US" i="1" dirty="0"/>
              <a:t>        S. </a:t>
            </a:r>
            <a:r>
              <a:rPr lang="en-US" i="1" dirty="0" err="1"/>
              <a:t>maritima</a:t>
            </a:r>
            <a:endParaRPr lang="en-US" i="1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F44EAA69-88D3-D641-B45B-FC82C55B109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7540" y="1308100"/>
            <a:ext cx="2565400" cy="4241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52412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141</Words>
  <Application>Microsoft Macintosh PowerPoint</Application>
  <PresentationFormat>Widescreen</PresentationFormat>
  <Paragraphs>25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mar, Shaifaly (NIH/NCI) [F]</dc:creator>
  <cp:lastModifiedBy>Birendra Shaw</cp:lastModifiedBy>
  <cp:revision>6</cp:revision>
  <dcterms:created xsi:type="dcterms:W3CDTF">2019-11-13T04:48:55Z</dcterms:created>
  <dcterms:modified xsi:type="dcterms:W3CDTF">2020-02-15T07:49:01Z</dcterms:modified>
</cp:coreProperties>
</file>